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흑백, 직사각형, 모노크롬, 블랙이(가) 표시된 사진&#10;&#10;자동 생성된 설명">
            <a:extLst>
              <a:ext uri="{FF2B5EF4-FFF2-40B4-BE49-F238E27FC236}">
                <a16:creationId xmlns:a16="http://schemas.microsoft.com/office/drawing/2014/main" id="{75B9A18D-7734-7C76-C607-7ADD43E49B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24" t="30499" r="29639" b="31196"/>
          <a:stretch/>
        </p:blipFill>
        <p:spPr>
          <a:xfrm rot="21336055">
            <a:off x="2819905" y="1734353"/>
            <a:ext cx="7841157" cy="4227926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677948" y="2785631"/>
            <a:ext cx="19913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LC </a:t>
            </a:r>
            <a:r>
              <a:rPr lang="el-GR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2669309" y="3079970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4304145" y="4549777"/>
            <a:ext cx="1293091" cy="1612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189A82AB-AD7B-C9CD-3F1B-BE25BC9F62C1}"/>
              </a:ext>
            </a:extLst>
          </p:cNvPr>
          <p:cNvCxnSpPr>
            <a:cxnSpLocks/>
          </p:cNvCxnSpPr>
          <p:nvPr/>
        </p:nvCxnSpPr>
        <p:spPr>
          <a:xfrm flipV="1">
            <a:off x="5828145" y="4548087"/>
            <a:ext cx="1366982" cy="835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>
            <a:off x="3955009" y="4548087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>
            <a:off x="5575068" y="4618663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917D2D-D796-3751-28C4-2660B417DBE2}"/>
              </a:ext>
            </a:extLst>
          </p:cNvPr>
          <p:cNvSpPr txBox="1"/>
          <p:nvPr/>
        </p:nvSpPr>
        <p:spPr>
          <a:xfrm>
            <a:off x="4131190" y="2416299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83D24D-89C4-E1C4-1E26-7681586EE976}"/>
              </a:ext>
            </a:extLst>
          </p:cNvPr>
          <p:cNvSpPr txBox="1"/>
          <p:nvPr/>
        </p:nvSpPr>
        <p:spPr>
          <a:xfrm>
            <a:off x="4515885" y="2424657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AF54D-C0DB-BA1F-09B4-B6A364AEDBBE}"/>
              </a:ext>
            </a:extLst>
          </p:cNvPr>
          <p:cNvSpPr txBox="1"/>
          <p:nvPr/>
        </p:nvSpPr>
        <p:spPr>
          <a:xfrm>
            <a:off x="4932902" y="2416299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16C23E-DDB7-8C61-EBD6-9B0451E9891B}"/>
              </a:ext>
            </a:extLst>
          </p:cNvPr>
          <p:cNvSpPr txBox="1"/>
          <p:nvPr/>
        </p:nvSpPr>
        <p:spPr>
          <a:xfrm>
            <a:off x="5220966" y="2424657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</a:t>
            </a:r>
            <a:r>
              <a:rPr lang="en-US" altLang="ko-KR"/>
              <a:t>of p-PLC γ1 </a:t>
            </a:r>
            <a:r>
              <a:rPr lang="en-US" altLang="ko-KR" dirty="0"/>
              <a:t>expression in total thymocytes from mice</a:t>
            </a:r>
          </a:p>
          <a:p>
            <a:r>
              <a:rPr lang="en-US" altLang="ko-KR" dirty="0"/>
              <a:t>(Fig 4C) 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74B1B6-2072-5F61-D91D-D5AC4F40F062}"/>
              </a:ext>
            </a:extLst>
          </p:cNvPr>
          <p:cNvSpPr txBox="1"/>
          <p:nvPr/>
        </p:nvSpPr>
        <p:spPr>
          <a:xfrm>
            <a:off x="5705532" y="2416299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84383D4-7859-78BB-B178-45EA6BC25F15}"/>
              </a:ext>
            </a:extLst>
          </p:cNvPr>
          <p:cNvSpPr txBox="1"/>
          <p:nvPr/>
        </p:nvSpPr>
        <p:spPr>
          <a:xfrm>
            <a:off x="6090227" y="2424657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95CEEF9-AEF0-308E-8E20-1E72C7026399}"/>
              </a:ext>
            </a:extLst>
          </p:cNvPr>
          <p:cNvSpPr txBox="1"/>
          <p:nvPr/>
        </p:nvSpPr>
        <p:spPr>
          <a:xfrm>
            <a:off x="6507244" y="2416299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B8AC67-B7EC-8BA7-B706-8F60D70CF50C}"/>
              </a:ext>
            </a:extLst>
          </p:cNvPr>
          <p:cNvSpPr txBox="1"/>
          <p:nvPr/>
        </p:nvSpPr>
        <p:spPr>
          <a:xfrm>
            <a:off x="6795308" y="2424657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1</Words>
  <Application>Microsoft Office PowerPoint</Application>
  <PresentationFormat>와이드스크린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5</cp:revision>
  <dcterms:created xsi:type="dcterms:W3CDTF">2024-02-08T02:01:38Z</dcterms:created>
  <dcterms:modified xsi:type="dcterms:W3CDTF">2024-02-08T04:17:20Z</dcterms:modified>
</cp:coreProperties>
</file>